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7" r:id="rId2"/>
    <p:sldId id="278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79" r:id="rId13"/>
  </p:sldIdLst>
  <p:sldSz cx="9144000" cy="6858000" type="screen4x3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630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75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27B76-30F9-4FB9-9D0D-FD61F576A257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9BA43-D71F-449D-B3B8-7CA0D74CA1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225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27B76-30F9-4FB9-9D0D-FD61F576A257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9BA43-D71F-449D-B3B8-7CA0D74CA1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011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27B76-30F9-4FB9-9D0D-FD61F576A257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9BA43-D71F-449D-B3B8-7CA0D74CA1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846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27B76-30F9-4FB9-9D0D-FD61F576A257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9BA43-D71F-449D-B3B8-7CA0D74CA1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195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27B76-30F9-4FB9-9D0D-FD61F576A257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9BA43-D71F-449D-B3B8-7CA0D74CA1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63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27B76-30F9-4FB9-9D0D-FD61F576A257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9BA43-D71F-449D-B3B8-7CA0D74CA1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701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27B76-30F9-4FB9-9D0D-FD61F576A257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9BA43-D71F-449D-B3B8-7CA0D74CA1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207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27B76-30F9-4FB9-9D0D-FD61F576A257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9BA43-D71F-449D-B3B8-7CA0D74CA1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544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27B76-30F9-4FB9-9D0D-FD61F576A257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9BA43-D71F-449D-B3B8-7CA0D74CA1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837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27B76-30F9-4FB9-9D0D-FD61F576A257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9BA43-D71F-449D-B3B8-7CA0D74CA1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949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27B76-30F9-4FB9-9D0D-FD61F576A257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9BA43-D71F-449D-B3B8-7CA0D74CA1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2115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727B76-30F9-4FB9-9D0D-FD61F576A257}" type="datetimeFigureOut">
              <a:rPr lang="en-US" smtClean="0"/>
              <a:t>11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E9BA43-D71F-449D-B3B8-7CA0D74CA1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616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8525285" y="-191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b="1" dirty="0">
                <a:latin typeface="Arial" pitchFamily="34" charset="0"/>
                <a:cs typeface="Arial" pitchFamily="34" charset="0"/>
              </a:rPr>
              <a:t>SF1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412102" y="218567"/>
            <a:ext cx="7051007" cy="4806619"/>
            <a:chOff x="412102" y="218567"/>
            <a:chExt cx="7051007" cy="4806619"/>
          </a:xfrm>
        </p:grpSpPr>
        <p:pic>
          <p:nvPicPr>
            <p:cNvPr id="5" name="Picture 3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782934" y="1523914"/>
              <a:ext cx="1732002" cy="1995865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6" name="Picture 11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5438765" y="687905"/>
              <a:ext cx="2024344" cy="1347992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7" name="Picture 13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449556" y="2112788"/>
              <a:ext cx="2013264" cy="1409025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8" name="Picture 14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5437599" y="3610296"/>
              <a:ext cx="2020919" cy="141489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20" name="TextBox 19"/>
            <p:cNvSpPr txBox="1"/>
            <p:nvPr/>
          </p:nvSpPr>
          <p:spPr>
            <a:xfrm rot="16200000">
              <a:off x="4983457" y="2623734"/>
              <a:ext cx="622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>
                  <a:latin typeface="Arial" pitchFamily="34" charset="0"/>
                  <a:cs typeface="Arial" pitchFamily="34" charset="0"/>
                </a:rPr>
                <a:t>HeLa</a:t>
              </a:r>
              <a:endParaRPr lang="en-IN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5002693" y="1205518"/>
              <a:ext cx="5838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>
                  <a:latin typeface="Arial" pitchFamily="34" charset="0"/>
                  <a:cs typeface="Arial" pitchFamily="34" charset="0"/>
                </a:rPr>
                <a:t>SiHa</a:t>
              </a:r>
              <a:endParaRPr lang="en-IN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4988266" y="4217661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itchFamily="34" charset="0"/>
                  <a:cs typeface="Arial" pitchFamily="34" charset="0"/>
                </a:rPr>
                <a:t>C33a</a:t>
              </a:r>
              <a:endParaRPr lang="en-IN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12102" y="218567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itchFamily="34" charset="0"/>
                  <a:cs typeface="Arial" pitchFamily="34" charset="0"/>
                </a:rPr>
                <a:t>A</a:t>
              </a:r>
              <a:endParaRPr lang="en-IN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789333" y="218567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itchFamily="34" charset="0"/>
                  <a:cs typeface="Arial" pitchFamily="34" charset="0"/>
                </a:rPr>
                <a:t>B</a:t>
              </a:r>
              <a:endParaRPr lang="en-IN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272663" y="1265096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err="1">
                  <a:latin typeface="Arial" pitchFamily="34" charset="0"/>
                  <a:cs typeface="Arial" pitchFamily="34" charset="0"/>
                </a:rPr>
                <a:t>SiHa</a:t>
              </a:r>
              <a:endParaRPr lang="en-IN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684375" y="1267369"/>
              <a:ext cx="5309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100" b="1" dirty="0" err="1">
                  <a:latin typeface="Arial" pitchFamily="34" charset="0"/>
                  <a:cs typeface="Arial" pitchFamily="34" charset="0"/>
                </a:rPr>
                <a:t>HeLa</a:t>
              </a:r>
              <a:endParaRPr lang="en-IN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082440" y="1283288"/>
              <a:ext cx="5229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itchFamily="34" charset="0"/>
                  <a:cs typeface="Arial" pitchFamily="34" charset="0"/>
                </a:rPr>
                <a:t>C33a</a:t>
              </a:r>
              <a:endParaRPr lang="en-IN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947393" y="1294666"/>
              <a:ext cx="3016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itchFamily="34" charset="0"/>
                  <a:cs typeface="Arial" pitchFamily="34" charset="0"/>
                </a:rPr>
                <a:t>M</a:t>
              </a:r>
              <a:endParaRPr lang="en-IN" sz="11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6"/>
            <a:srcRect l="13751"/>
            <a:stretch/>
          </p:blipFill>
          <p:spPr>
            <a:xfrm rot="16200000">
              <a:off x="468522" y="2249878"/>
              <a:ext cx="1986888" cy="607433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928283" y="325957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92257" y="1785872"/>
              <a:ext cx="5774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0000</a:t>
              </a:r>
              <a:endParaRPr lang="en-IN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63480" y="2446858"/>
              <a:ext cx="49885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  <a:endParaRPr lang="en-IN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850555" y="2987504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IN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78475" y="5654333"/>
            <a:ext cx="90995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F1: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xosoma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RNA characterization: 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NA Library tape station profile indicating the total RNA start-end regions, and averag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ize for eac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xosom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NA preparatio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tal RNA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lectropherogra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xosom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NA on Agilent 2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z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herein Y-axis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lectropherogra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presents the arbitrary fluorescence unit (FU) intensity and X-axis represents size of transcripts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36453508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301746" y="112019"/>
            <a:ext cx="2563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GnRH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SECRETIO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525285" y="-191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b="1" dirty="0">
                <a:latin typeface="Arial" pitchFamily="34" charset="0"/>
                <a:cs typeface="Arial" pitchFamily="34" charset="0"/>
              </a:rPr>
              <a:t>SF3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0" y="-48084"/>
            <a:ext cx="325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H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3615" y="6324806"/>
            <a:ext cx="90995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F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EGG Analysis of differentially expressed transcripts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xosom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NA of HPV-negative vs. HPV-positive cervical cancer cells.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90581"/>
            <a:ext cx="9144000" cy="55880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68141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094104" y="77717"/>
            <a:ext cx="2955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ORPHINE ADDICTION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525285" y="-191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b="1" dirty="0">
                <a:latin typeface="Arial" pitchFamily="34" charset="0"/>
                <a:cs typeface="Arial" pitchFamily="34" charset="0"/>
              </a:rPr>
              <a:t>SF3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0" y="-48084"/>
            <a:ext cx="325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I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3615" y="6324806"/>
            <a:ext cx="90995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F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EGG Analysis of differentially expressed transcripts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xosom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NA of HPV-negative vs. HPV-positive cervical cancer cells.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0856" y="502773"/>
            <a:ext cx="9154856" cy="574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731471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139" t="35350" r="6758" b="42040"/>
          <a:stretch/>
        </p:blipFill>
        <p:spPr>
          <a:xfrm>
            <a:off x="2410388" y="2719259"/>
            <a:ext cx="3527151" cy="1627046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 rot="16200000">
            <a:off x="4130157" y="2188771"/>
            <a:ext cx="7312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C33a </a:t>
            </a:r>
            <a:endParaRPr lang="en-IN" sz="1600" b="1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6200000">
            <a:off x="3738961" y="2212014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HeLa</a:t>
            </a:r>
            <a:endParaRPr lang="en-IN" sz="1600" b="1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6200000">
            <a:off x="3230723" y="2205602"/>
            <a:ext cx="6976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SiHa</a:t>
            </a:r>
            <a:r>
              <a:rPr lang="en-US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 </a:t>
            </a:r>
            <a:endParaRPr lang="en-IN" sz="1600" b="1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5913135" y="3740941"/>
            <a:ext cx="1539221" cy="307777"/>
            <a:chOff x="4462934" y="1476590"/>
            <a:chExt cx="1539221" cy="307777"/>
          </a:xfrm>
        </p:grpSpPr>
        <p:sp>
          <p:nvSpPr>
            <p:cNvPr id="45" name="TextBox 44"/>
            <p:cNvSpPr txBox="1"/>
            <p:nvPr/>
          </p:nvSpPr>
          <p:spPr>
            <a:xfrm>
              <a:off x="4522263" y="1476590"/>
              <a:ext cx="1479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78">
                <a:defRPr/>
              </a:pPr>
              <a:r>
                <a:rPr lang="en-US" sz="1400" b="1" kern="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itchFamily="34" charset="0"/>
                  <a:cs typeface="Arial" pitchFamily="34" charset="0"/>
                </a:rPr>
                <a:t>HSP70 (70KDa)</a:t>
              </a:r>
              <a:endParaRPr lang="en-IN" sz="1400" b="1" kern="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9" name="Straight Arrow Connector 48"/>
            <p:cNvCxnSpPr/>
            <p:nvPr/>
          </p:nvCxnSpPr>
          <p:spPr>
            <a:xfrm flipH="1">
              <a:off x="4462934" y="1630479"/>
              <a:ext cx="58737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39" t="38449" r="27556" b="39409"/>
          <a:stretch/>
        </p:blipFill>
        <p:spPr>
          <a:xfrm>
            <a:off x="3131822" y="496015"/>
            <a:ext cx="2363724" cy="1347485"/>
          </a:xfrm>
          <a:prstGeom prst="rect">
            <a:avLst/>
          </a:prstGeom>
        </p:spPr>
      </p:pic>
      <p:grpSp>
        <p:nvGrpSpPr>
          <p:cNvPr id="15" name="Group 14"/>
          <p:cNvGrpSpPr/>
          <p:nvPr/>
        </p:nvGrpSpPr>
        <p:grpSpPr>
          <a:xfrm>
            <a:off x="5607912" y="1064312"/>
            <a:ext cx="1440178" cy="307777"/>
            <a:chOff x="7452356" y="480388"/>
            <a:chExt cx="1440178" cy="307777"/>
          </a:xfrm>
        </p:grpSpPr>
        <p:sp>
          <p:nvSpPr>
            <p:cNvPr id="46" name="TextBox 45"/>
            <p:cNvSpPr txBox="1"/>
            <p:nvPr/>
          </p:nvSpPr>
          <p:spPr>
            <a:xfrm>
              <a:off x="7553706" y="480388"/>
              <a:ext cx="13388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378">
                <a:defRPr/>
              </a:pPr>
              <a:r>
                <a:rPr lang="en-US" sz="1400" b="1" kern="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itchFamily="34" charset="0"/>
                  <a:cs typeface="Arial" pitchFamily="34" charset="0"/>
                </a:rPr>
                <a:t>Alix</a:t>
              </a:r>
              <a:r>
                <a:rPr lang="en-US" sz="1400" b="1" kern="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itchFamily="34" charset="0"/>
                  <a:cs typeface="Arial" pitchFamily="34" charset="0"/>
                </a:rPr>
                <a:t>  (97KDa)</a:t>
              </a:r>
              <a:endParaRPr lang="en-IN" sz="1400" b="1" kern="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0" name="Straight Arrow Connector 49"/>
            <p:cNvCxnSpPr/>
            <p:nvPr/>
          </p:nvCxnSpPr>
          <p:spPr>
            <a:xfrm flipH="1">
              <a:off x="7452356" y="634276"/>
              <a:ext cx="58737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0" name="TextBox 59"/>
          <p:cNvSpPr txBox="1"/>
          <p:nvPr/>
        </p:nvSpPr>
        <p:spPr>
          <a:xfrm rot="16200000">
            <a:off x="4615804" y="24923"/>
            <a:ext cx="7312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C33a </a:t>
            </a:r>
            <a:endParaRPr lang="en-IN" sz="1600" b="1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 rot="16200000">
            <a:off x="3984123" y="48166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HeLa</a:t>
            </a:r>
            <a:endParaRPr lang="en-IN" sz="1600" b="1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rot="16200000">
            <a:off x="3442241" y="41754"/>
            <a:ext cx="6976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SiHa</a:t>
            </a:r>
            <a:r>
              <a:rPr lang="en-US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 </a:t>
            </a:r>
            <a:endParaRPr lang="en-IN" sz="1600" b="1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239" t="-36267" r="-31383" b="-37627"/>
          <a:stretch/>
        </p:blipFill>
        <p:spPr>
          <a:xfrm>
            <a:off x="3131821" y="4869179"/>
            <a:ext cx="3600445" cy="2160266"/>
          </a:xfrm>
          <a:prstGeom prst="rect">
            <a:avLst/>
          </a:prstGeom>
        </p:spPr>
      </p:pic>
      <p:grpSp>
        <p:nvGrpSpPr>
          <p:cNvPr id="55" name="Group 54"/>
          <p:cNvGrpSpPr/>
          <p:nvPr/>
        </p:nvGrpSpPr>
        <p:grpSpPr>
          <a:xfrm>
            <a:off x="5913135" y="5653882"/>
            <a:ext cx="1805797" cy="307777"/>
            <a:chOff x="10945998" y="3594083"/>
            <a:chExt cx="1805797" cy="307777"/>
          </a:xfrm>
        </p:grpSpPr>
        <p:cxnSp>
          <p:nvCxnSpPr>
            <p:cNvPr id="56" name="Straight Arrow Connector 55"/>
            <p:cNvCxnSpPr/>
            <p:nvPr/>
          </p:nvCxnSpPr>
          <p:spPr>
            <a:xfrm flipH="1">
              <a:off x="10945998" y="3752047"/>
              <a:ext cx="58737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11037864" y="3594083"/>
              <a:ext cx="17139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>
                <a:defRPr/>
              </a:pPr>
              <a:r>
                <a:rPr lang="en-US" sz="1400" b="1" kern="0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itchFamily="34" charset="0"/>
                  <a:cs typeface="Arial" pitchFamily="34" charset="0"/>
                </a:rPr>
                <a:t>Flotillin</a:t>
              </a:r>
              <a:r>
                <a:rPr lang="en-US" sz="1400" b="1" kern="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itchFamily="34" charset="0"/>
                  <a:cs typeface="Arial" pitchFamily="34" charset="0"/>
                </a:rPr>
                <a:t> 2 (</a:t>
              </a:r>
              <a:r>
                <a:rPr lang="en-US" sz="1400" b="1" dirty="0">
                  <a:latin typeface="Arial" pitchFamily="34" charset="0"/>
                  <a:cs typeface="Arial" pitchFamily="34" charset="0"/>
                </a:rPr>
                <a:t>43 </a:t>
              </a:r>
              <a:r>
                <a:rPr lang="en-US" sz="1400" b="1" dirty="0" err="1">
                  <a:latin typeface="Arial" pitchFamily="34" charset="0"/>
                  <a:cs typeface="Arial" pitchFamily="34" charset="0"/>
                </a:rPr>
                <a:t>kDa</a:t>
              </a:r>
              <a:r>
                <a:rPr lang="en-US" sz="1400" b="1" dirty="0">
                  <a:latin typeface="Arial" pitchFamily="34" charset="0"/>
                  <a:cs typeface="Arial" pitchFamily="34" charset="0"/>
                </a:rPr>
                <a:t>)</a:t>
              </a:r>
              <a:endParaRPr lang="en-IN" sz="1400" b="1" kern="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72" name="TextBox 71"/>
          <p:cNvSpPr txBox="1"/>
          <p:nvPr/>
        </p:nvSpPr>
        <p:spPr>
          <a:xfrm rot="16200000">
            <a:off x="4780697" y="4847647"/>
            <a:ext cx="7312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C33a </a:t>
            </a:r>
            <a:endParaRPr lang="en-IN" sz="1600" b="1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 rot="16200000">
            <a:off x="4029558" y="4847645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HeLa</a:t>
            </a:r>
            <a:endParaRPr lang="en-IN" sz="1600" b="1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 rot="16200000">
            <a:off x="3198944" y="4854056"/>
            <a:ext cx="6976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SiHa</a:t>
            </a:r>
            <a:r>
              <a:rPr lang="en-US" sz="16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 </a:t>
            </a:r>
            <a:endParaRPr lang="en-IN" sz="1600" b="1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0" y="-5859"/>
            <a:ext cx="29586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munoblots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or Figure 1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8534400" y="24923"/>
            <a:ext cx="609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F4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03888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8525285" y="-191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b="1" dirty="0">
                <a:latin typeface="Arial" pitchFamily="34" charset="0"/>
                <a:cs typeface="Arial" pitchFamily="34" charset="0"/>
              </a:rPr>
              <a:t>SF2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/>
          <a:srcRect t="9378"/>
          <a:stretch/>
        </p:blipFill>
        <p:spPr>
          <a:xfrm>
            <a:off x="33615" y="954295"/>
            <a:ext cx="4538384" cy="4706433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>
            <a:off x="33615" y="5660728"/>
            <a:ext cx="90548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F2: Relationship between the assembled transcripts and closely related reference transcripts: 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mmary of assembled transcripts and the relation with reference transcripts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ey for relationship codes of assembled transcripts with reference transcripts.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1999" y="967742"/>
            <a:ext cx="4516455" cy="444560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/>
          <p:cNvSpPr txBox="1"/>
          <p:nvPr/>
        </p:nvSpPr>
        <p:spPr>
          <a:xfrm>
            <a:off x="33615" y="2700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A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587628" y="21856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B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8629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803710" y="108645"/>
            <a:ext cx="3778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ALCIUM SIGNALING PATHWAY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3615" y="6324806"/>
            <a:ext cx="90995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F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EGG Analysis of differentially expressed transcripts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xosom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NA of HPV-negative vs. HPV-positive cervical cancer cells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525285" y="-191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b="1" dirty="0">
                <a:latin typeface="Arial" pitchFamily="34" charset="0"/>
                <a:cs typeface="Arial" pitchFamily="34" charset="0"/>
              </a:rPr>
              <a:t>SF3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-48084"/>
            <a:ext cx="325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A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0856" y="632012"/>
            <a:ext cx="9154856" cy="5688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47486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884786" y="78768"/>
            <a:ext cx="3778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cAMP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SIGNALING PATHWAY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525285" y="-191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b="1" dirty="0">
                <a:latin typeface="Arial" pitchFamily="34" charset="0"/>
                <a:cs typeface="Arial" pitchFamily="34" charset="0"/>
              </a:rPr>
              <a:t>SF3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0" y="-48084"/>
            <a:ext cx="325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B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3615" y="6324806"/>
            <a:ext cx="90995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F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EGG Analysis of differentially expressed transcripts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xosom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NA of HPV-negative vs. HPV-positive cervical cancer cells.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78224"/>
            <a:ext cx="9144000" cy="57465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53494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064297" y="11966"/>
            <a:ext cx="50381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XON GUIDANCE SIGNALING PATHWAY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8525285" y="-191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b="1" dirty="0">
                <a:latin typeface="Arial" pitchFamily="34" charset="0"/>
                <a:cs typeface="Arial" pitchFamily="34" charset="0"/>
              </a:rPr>
              <a:t>SF3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0" y="-48084"/>
            <a:ext cx="325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C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3615" y="6459276"/>
            <a:ext cx="90995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F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EGG Analysis of differentially expressed transcripts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xosom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NA of HPV-negative vs. HPV-positive cervical cancer cells.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15" y="537882"/>
            <a:ext cx="9143999" cy="59424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25349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766687" y="101705"/>
            <a:ext cx="5610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EUKOCYTE TRANSENDOTHELIAL MIGRATIO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525285" y="-191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b="1" dirty="0">
                <a:latin typeface="Arial" pitchFamily="34" charset="0"/>
                <a:cs typeface="Arial" pitchFamily="34" charset="0"/>
              </a:rPr>
              <a:t>SF3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0" y="-48084"/>
            <a:ext cx="325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D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2234" y="6443282"/>
            <a:ext cx="90995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F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EGG Analysis of differentially expressed transcripts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xosom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NA of HPV-negative vs. HPV-positive cervical cancer cells.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78224"/>
            <a:ext cx="9144000" cy="57927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73496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900402" y="0"/>
            <a:ext cx="3343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IRCADIAN ENTRAINMENT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525285" y="-191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b="1" dirty="0">
                <a:latin typeface="Arial" pitchFamily="34" charset="0"/>
                <a:cs typeface="Arial" pitchFamily="34" charset="0"/>
              </a:rPr>
              <a:t>SF3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0" y="-48084"/>
            <a:ext cx="325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E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3615" y="6324806"/>
            <a:ext cx="90995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F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EGG Analysis of differentially expressed transcripts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xosom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NA of HPV-negative vs. HPV-positive cervical cancer cells.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84094"/>
            <a:ext cx="9144000" cy="57926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85975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615946" y="31117"/>
            <a:ext cx="39348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ONG-TERM POTENTIATIO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525285" y="-191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b="1" dirty="0">
                <a:latin typeface="Arial" pitchFamily="34" charset="0"/>
                <a:cs typeface="Arial" pitchFamily="34" charset="0"/>
              </a:rPr>
              <a:t>SF3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0" y="-48084"/>
            <a:ext cx="325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F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3615" y="6324806"/>
            <a:ext cx="90995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F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EGG Analysis of differentially expressed transcripts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xosom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NA of HPV-negative vs. HPV-positive cervical cancer cells.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15525"/>
            <a:ext cx="9144000" cy="57335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119243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718868" y="-1917"/>
            <a:ext cx="37062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LUTAMATERGIC SYNAPSE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525285" y="-191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b="1" dirty="0">
                <a:latin typeface="Arial" pitchFamily="34" charset="0"/>
                <a:cs typeface="Arial" pitchFamily="34" charset="0"/>
              </a:rPr>
              <a:t>SF3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0" y="-48084"/>
            <a:ext cx="325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G</a:t>
            </a:r>
            <a:endParaRPr lang="en-I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4471" y="6418894"/>
            <a:ext cx="90995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F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EGG Analysis of differentially expressed transcripts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xosom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NA of HPV-negative vs. HPV-positive cervical cancer cells.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67415"/>
            <a:ext cx="9144000" cy="60053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18537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1</TotalTime>
  <Words>368</Words>
  <Application>Microsoft Office PowerPoint</Application>
  <PresentationFormat>On-screen Show (4:3)</PresentationFormat>
  <Paragraphs>69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ACB</cp:lastModifiedBy>
  <cp:revision>27</cp:revision>
  <dcterms:created xsi:type="dcterms:W3CDTF">2020-11-09T07:49:14Z</dcterms:created>
  <dcterms:modified xsi:type="dcterms:W3CDTF">2021-11-30T12:36:04Z</dcterms:modified>
</cp:coreProperties>
</file>